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09E03B-835F-4A4C-B488-5ABD0DE6241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8EE41D-CE2F-4235-8EC7-C98B89FA0F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832115-9151-4332-ADCD-71BA4DE80D4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63490B-BDBB-42F4-85A4-540CF41CF27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9196AE-D76B-452E-95D3-C0456D5DC6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57D8A3-27B4-42C6-85E7-49D020BA8F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2E108F-B544-4F58-8CE7-69C87EB8CF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6E027B-4F84-4065-94A0-C6576D05BC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C1808D-A789-4234-9199-809AAAFCB9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11AC2B-BB9C-4EE9-9EE6-7398A043D7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0B4AB7-FC1D-46F0-BE95-40F41A82C9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B98CA8-DC37-4D0A-B12B-34574CAD94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24290A-4BB5-4C00-ACF2-BEB2C205D10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C:\Users\stuart\Documents\My Dropbox\carot stuff july2010\A CAROT OCT 2010\CAROR ARRAYS OCT10\ARRAYS NOV 18\CAROT ARRAYS NOV 18\PSY50 SEED DEVELCROP.tif"/>
          <p:cNvPicPr/>
          <p:nvPr/>
        </p:nvPicPr>
        <p:blipFill>
          <a:blip r:embed="rId1"/>
          <a:stretch/>
        </p:blipFill>
        <p:spPr>
          <a:xfrm>
            <a:off x="990720" y="1981080"/>
            <a:ext cx="7315200" cy="28638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13" descr="C:\Users\stuart\Documents\My Dropbox\carot stuff july2010\A CAROT OCT 2010\CAROR ARRAYS OCT10\HEAT MAPS\crop_gimp_scale barCAROT DEVEL 50-900.tif"/>
          <p:cNvPicPr/>
          <p:nvPr/>
        </p:nvPicPr>
        <p:blipFill>
          <a:blip r:embed="rId2"/>
          <a:stretch/>
        </p:blipFill>
        <p:spPr>
          <a:xfrm>
            <a:off x="914400" y="514440"/>
            <a:ext cx="5867280" cy="241200"/>
          </a:xfrm>
          <a:prstGeom prst="rect">
            <a:avLst/>
          </a:prstGeom>
          <a:ln w="0">
            <a:noFill/>
          </a:ln>
        </p:spPr>
      </p:pic>
      <p:sp>
        <p:nvSpPr>
          <p:cNvPr id="43" name="TextBox 14"/>
          <p:cNvSpPr/>
          <p:nvPr/>
        </p:nvSpPr>
        <p:spPr>
          <a:xfrm>
            <a:off x="1002600" y="1730520"/>
            <a:ext cx="216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     4     5     6     7     8     9    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15"/>
          <p:cNvSpPr/>
          <p:nvPr/>
        </p:nvSpPr>
        <p:spPr>
          <a:xfrm>
            <a:off x="1276560" y="819000"/>
            <a:ext cx="1553760" cy="48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eed developme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stage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16"/>
          <p:cNvSpPr/>
          <p:nvPr/>
        </p:nvSpPr>
        <p:spPr>
          <a:xfrm rot="16200000">
            <a:off x="3319200" y="1044720"/>
            <a:ext cx="1038600" cy="81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Aft>
                <a:spcPts val="7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d strat. se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7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d dar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7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d c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17"/>
          <p:cNvSpPr/>
          <p:nvPr/>
        </p:nvSpPr>
        <p:spPr>
          <a:xfrm rot="16200000">
            <a:off x="4280400" y="695520"/>
            <a:ext cx="1606680" cy="109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Aft>
                <a:spcPts val="7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ry se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7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4h imb (w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7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4h imb (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ba2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7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4h imb (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yp707 tri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8"/>
          <p:cNvSpPr/>
          <p:nvPr/>
        </p:nvSpPr>
        <p:spPr>
          <a:xfrm rot="16200000">
            <a:off x="5657760" y="951840"/>
            <a:ext cx="1390680" cy="819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Aft>
                <a:spcPts val="7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4h ger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7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4h germ – AB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70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4h germ - PA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eft Brace 19"/>
          <p:cNvSpPr/>
          <p:nvPr/>
        </p:nvSpPr>
        <p:spPr>
          <a:xfrm rot="5400000">
            <a:off x="1866960" y="551880"/>
            <a:ext cx="380880" cy="1981440"/>
          </a:xfrm>
          <a:custGeom>
            <a:avLst/>
            <a:gdLst>
              <a:gd name="textAreaLeft" fmla="*/ 243360 w 380880"/>
              <a:gd name="textAreaRight" fmla="*/ 381240 w 380880"/>
              <a:gd name="textAreaTop" fmla="*/ 9720 h 1981440"/>
              <a:gd name="textAreaBottom" fmla="*/ 1971720 h 19814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73"/>
                  <a:pt x="10800" y="346"/>
                </a:cubicBezTo>
                <a:lnTo>
                  <a:pt x="10800" y="10454"/>
                </a:lnTo>
                <a:cubicBezTo>
                  <a:pt x="10800" y="10627"/>
                  <a:pt x="5400" y="10800"/>
                  <a:pt x="0" y="10800"/>
                </a:cubicBezTo>
                <a:cubicBezTo>
                  <a:pt x="5400" y="10800"/>
                  <a:pt x="10800" y="10973"/>
                  <a:pt x="10800" y="11146"/>
                </a:cubicBezTo>
                <a:lnTo>
                  <a:pt x="10800" y="21254"/>
                </a:lnTo>
                <a:cubicBezTo>
                  <a:pt x="10800" y="21427"/>
                  <a:pt x="16200" y="21600"/>
                  <a:pt x="21600" y="21600"/>
                </a:cubicBez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20"/>
          <p:cNvSpPr/>
          <p:nvPr/>
        </p:nvSpPr>
        <p:spPr>
          <a:xfrm>
            <a:off x="840600" y="617400"/>
            <a:ext cx="33300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21"/>
          <p:cNvSpPr/>
          <p:nvPr/>
        </p:nvSpPr>
        <p:spPr>
          <a:xfrm>
            <a:off x="6480360" y="638280"/>
            <a:ext cx="40932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22"/>
          <p:cNvSpPr/>
          <p:nvPr/>
        </p:nvSpPr>
        <p:spPr>
          <a:xfrm>
            <a:off x="7057440" y="438120"/>
            <a:ext cx="947160" cy="459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rmalise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gn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" name="Group 24"/>
          <p:cNvGrpSpPr/>
          <p:nvPr/>
        </p:nvGrpSpPr>
        <p:grpSpPr>
          <a:xfrm>
            <a:off x="685800" y="1023840"/>
            <a:ext cx="7010280" cy="4826160"/>
            <a:chOff x="685800" y="1023840"/>
            <a:chExt cx="7010280" cy="4826160"/>
          </a:xfrm>
        </p:grpSpPr>
        <p:sp>
          <p:nvSpPr>
            <p:cNvPr id="53" name="TextBox 13"/>
            <p:cNvSpPr/>
            <p:nvPr/>
          </p:nvSpPr>
          <p:spPr>
            <a:xfrm rot="16200000">
              <a:off x="713880" y="1773720"/>
              <a:ext cx="1119600" cy="109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Aft>
                  <a:spcPts val="700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FR 6h (et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spcAft>
                  <a:spcPts val="700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FR 6h (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hyA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spcAft>
                  <a:spcPts val="700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R 6h (wt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spcAft>
                  <a:spcPts val="700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R 6h (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hyB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14"/>
            <p:cNvSpPr/>
            <p:nvPr/>
          </p:nvSpPr>
          <p:spPr>
            <a:xfrm rot="16200000">
              <a:off x="2050920" y="1749600"/>
              <a:ext cx="1188360" cy="109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Aft>
                  <a:spcPts val="700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d Dk / stra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spcAft>
                  <a:spcPts val="700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h cR / 2d Dk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spcAft>
                  <a:spcPts val="700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d cR / 2d Dk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spcAft>
                  <a:spcPts val="700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ifq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/wt - 2d Dk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15"/>
            <p:cNvSpPr/>
            <p:nvPr/>
          </p:nvSpPr>
          <p:spPr>
            <a:xfrm rot="16200000">
              <a:off x="3283560" y="2053080"/>
              <a:ext cx="1107360" cy="547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Aft>
                  <a:spcPts val="700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YHB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/ wt (Dk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spcAft>
                  <a:spcPts val="700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R / Dk (wt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16"/>
            <p:cNvSpPr/>
            <p:nvPr/>
          </p:nvSpPr>
          <p:spPr>
            <a:xfrm rot="16200000">
              <a:off x="4524840" y="1414080"/>
              <a:ext cx="1324800" cy="1633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Aft>
                  <a:spcPts val="700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rx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/ wt (Sht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spcAft>
                  <a:spcPts val="700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L 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rx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/ 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rx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Sht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spcAft>
                  <a:spcPts val="700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L wt / wt (Sht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spcAft>
                  <a:spcPts val="700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L 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rx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/ wt (Sht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spcAft>
                  <a:spcPts val="700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rx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/ wt (Rt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spcAft>
                  <a:spcPts val="700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sc. 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rx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/ wt (Rt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7" name="Picture 4" descr="C:\Users\stuart\Documents\My Dropbox\CAROT stuff july2010\MARCH 2011\FIGS TABLES EDIT\arrays\CROP PSY50mut no yucca.tif"/>
            <p:cNvPicPr/>
            <p:nvPr/>
          </p:nvPicPr>
          <p:blipFill>
            <a:blip r:embed="rId1"/>
            <a:stretch/>
          </p:blipFill>
          <p:spPr>
            <a:xfrm>
              <a:off x="685800" y="2895480"/>
              <a:ext cx="7010280" cy="29545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8" name="Group 20"/>
            <p:cNvGrpSpPr/>
            <p:nvPr/>
          </p:nvGrpSpPr>
          <p:grpSpPr>
            <a:xfrm>
              <a:off x="1004400" y="1023840"/>
              <a:ext cx="4695480" cy="423720"/>
              <a:chOff x="1004400" y="1023840"/>
              <a:chExt cx="4695480" cy="423720"/>
            </a:xfrm>
          </p:grpSpPr>
          <p:pic>
            <p:nvPicPr>
              <p:cNvPr id="59" name="Picture 3" descr="C:\Users\stuart\Documents\My Dropbox\carot stuff july2010\A CAROT OCT 2010\CAROR ARRAYS OCT10\ARRAYS NOV 18\CAROT ARRAYS NOV 18\PSY50 OSMOTIC scale bar.tif"/>
              <p:cNvPicPr/>
              <p:nvPr/>
            </p:nvPicPr>
            <p:blipFill>
              <a:blip r:embed="rId2"/>
              <a:stretch/>
            </p:blipFill>
            <p:spPr>
              <a:xfrm>
                <a:off x="1153080" y="1301760"/>
                <a:ext cx="3999600" cy="145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0" name="TextBox 3"/>
              <p:cNvSpPr/>
              <p:nvPr/>
            </p:nvSpPr>
            <p:spPr>
              <a:xfrm>
                <a:off x="1004400" y="1023840"/>
                <a:ext cx="421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1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TextBox 4"/>
              <p:cNvSpPr/>
              <p:nvPr/>
            </p:nvSpPr>
            <p:spPr>
              <a:xfrm>
                <a:off x="4768920" y="1023840"/>
                <a:ext cx="371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TextBox 5"/>
              <p:cNvSpPr/>
              <p:nvPr/>
            </p:nvSpPr>
            <p:spPr>
              <a:xfrm>
                <a:off x="3045600" y="1023840"/>
                <a:ext cx="257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TextBox 6"/>
              <p:cNvSpPr/>
              <p:nvPr/>
            </p:nvSpPr>
            <p:spPr>
              <a:xfrm>
                <a:off x="5247720" y="1023840"/>
                <a:ext cx="452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og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4" name="Group 20"/>
          <p:cNvGrpSpPr/>
          <p:nvPr/>
        </p:nvGrpSpPr>
        <p:grpSpPr>
          <a:xfrm>
            <a:off x="990360" y="1023840"/>
            <a:ext cx="4422240" cy="347760"/>
            <a:chOff x="990360" y="1023840"/>
            <a:chExt cx="4422240" cy="347760"/>
          </a:xfrm>
        </p:grpSpPr>
        <p:pic>
          <p:nvPicPr>
            <p:cNvPr id="65" name="Picture 3" descr="C:\Users\stuart\Documents\My Dropbox\carot stuff july2010\A CAROT OCT 2010\CAROR ARRAYS OCT10\ARRAYS NOV 18\CAROT ARRAYS NOV 18\PSY50 OSMOTIC scale bar.tif"/>
            <p:cNvPicPr/>
            <p:nvPr/>
          </p:nvPicPr>
          <p:blipFill>
            <a:blip r:embed="rId1"/>
            <a:stretch/>
          </p:blipFill>
          <p:spPr>
            <a:xfrm>
              <a:off x="1143000" y="1252080"/>
              <a:ext cx="3742920" cy="119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6" name="TextBox 3"/>
            <p:cNvSpPr/>
            <p:nvPr/>
          </p:nvSpPr>
          <p:spPr>
            <a:xfrm>
              <a:off x="990360" y="1023840"/>
              <a:ext cx="421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1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Box 4"/>
            <p:cNvSpPr/>
            <p:nvPr/>
          </p:nvSpPr>
          <p:spPr>
            <a:xfrm>
              <a:off x="4515120" y="1023840"/>
              <a:ext cx="37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Box 5"/>
            <p:cNvSpPr/>
            <p:nvPr/>
          </p:nvSpPr>
          <p:spPr>
            <a:xfrm>
              <a:off x="2905920" y="102384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Box 6"/>
            <p:cNvSpPr/>
            <p:nvPr/>
          </p:nvSpPr>
          <p:spPr>
            <a:xfrm>
              <a:off x="4960440" y="1023840"/>
              <a:ext cx="45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log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0" name="Group 21"/>
          <p:cNvGrpSpPr/>
          <p:nvPr/>
        </p:nvGrpSpPr>
        <p:grpSpPr>
          <a:xfrm>
            <a:off x="1219320" y="1481040"/>
            <a:ext cx="5257800" cy="3929040"/>
            <a:chOff x="1219320" y="1481040"/>
            <a:chExt cx="5257800" cy="3929040"/>
          </a:xfrm>
        </p:grpSpPr>
        <p:pic>
          <p:nvPicPr>
            <p:cNvPr id="71" name="Picture 2" descr="C:\Users\stuart\Documents\My Dropbox\carot stuff july2010\A CAROT OCT 2010\CAROR ARRAYS OCT10\ARRAYS NOV 18\CAROT ARRAYS NOV 18\PSY50 OSMOTIC crop.tif"/>
            <p:cNvPicPr/>
            <p:nvPr/>
          </p:nvPicPr>
          <p:blipFill>
            <a:blip r:embed="rId2"/>
            <a:stretch/>
          </p:blipFill>
          <p:spPr>
            <a:xfrm>
              <a:off x="1219320" y="2471400"/>
              <a:ext cx="5257800" cy="29386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72" name="Group 15"/>
            <p:cNvGrpSpPr/>
            <p:nvPr/>
          </p:nvGrpSpPr>
          <p:grpSpPr>
            <a:xfrm>
              <a:off x="1219320" y="1481040"/>
              <a:ext cx="4519440" cy="1144800"/>
              <a:chOff x="1219320" y="1481040"/>
              <a:chExt cx="4519440" cy="1144800"/>
            </a:xfrm>
          </p:grpSpPr>
          <p:sp>
            <p:nvSpPr>
              <p:cNvPr id="73" name="TextBox 16"/>
              <p:cNvSpPr/>
              <p:nvPr/>
            </p:nvSpPr>
            <p:spPr>
              <a:xfrm>
                <a:off x="1219320" y="1481040"/>
                <a:ext cx="3734280" cy="596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spcAft>
                    <a:spcPts val="6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Osmotic stres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spcAft>
                    <a:spcPts val="6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oot                                  shoot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TextBox 17"/>
              <p:cNvSpPr/>
              <p:nvPr/>
            </p:nvSpPr>
            <p:spPr>
              <a:xfrm>
                <a:off x="1275480" y="2166840"/>
                <a:ext cx="446328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      3     6     12   18    24          1      3     6     12   18    24 (time hour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18T15:29:07Z</dcterms:created>
  <dc:creator>stuart</dc:creator>
  <dc:description/>
  <dc:language>en-US</dc:language>
  <cp:lastModifiedBy>stuart</cp:lastModifiedBy>
  <dcterms:modified xsi:type="dcterms:W3CDTF">2011-03-19T14:11:07Z</dcterms:modified>
  <cp:revision>9</cp:revision>
  <dc:subject/>
  <dc:title>Slide 1</dc:title>
</cp:coreProperties>
</file>